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6" d="100"/>
          <a:sy n="66" d="100"/>
        </p:scale>
        <p:origin x="600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1FC4D3-CDC5-46F2-91B6-FE483614515A}" type="datetimeFigureOut">
              <a:rPr lang="en-IN" smtClean="0"/>
              <a:t>01-03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7B13F-1CF0-4BF4-9E3D-A23CCCCC9FE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686239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1FC4D3-CDC5-46F2-91B6-FE483614515A}" type="datetimeFigureOut">
              <a:rPr lang="en-IN" smtClean="0"/>
              <a:t>01-03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7B13F-1CF0-4BF4-9E3D-A23CCCCC9FE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18736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1FC4D3-CDC5-46F2-91B6-FE483614515A}" type="datetimeFigureOut">
              <a:rPr lang="en-IN" smtClean="0"/>
              <a:t>01-03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7B13F-1CF0-4BF4-9E3D-A23CCCCC9FE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247399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1FC4D3-CDC5-46F2-91B6-FE483614515A}" type="datetimeFigureOut">
              <a:rPr lang="en-IN" smtClean="0"/>
              <a:t>01-03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7B13F-1CF0-4BF4-9E3D-A23CCCCC9FE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581925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1FC4D3-CDC5-46F2-91B6-FE483614515A}" type="datetimeFigureOut">
              <a:rPr lang="en-IN" smtClean="0"/>
              <a:t>01-03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7B13F-1CF0-4BF4-9E3D-A23CCCCC9FE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564148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1FC4D3-CDC5-46F2-91B6-FE483614515A}" type="datetimeFigureOut">
              <a:rPr lang="en-IN" smtClean="0"/>
              <a:t>01-03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7B13F-1CF0-4BF4-9E3D-A23CCCCC9FE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357892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1FC4D3-CDC5-46F2-91B6-FE483614515A}" type="datetimeFigureOut">
              <a:rPr lang="en-IN" smtClean="0"/>
              <a:t>01-03-2024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7B13F-1CF0-4BF4-9E3D-A23CCCCC9FE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940961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1FC4D3-CDC5-46F2-91B6-FE483614515A}" type="datetimeFigureOut">
              <a:rPr lang="en-IN" smtClean="0"/>
              <a:t>01-03-2024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7B13F-1CF0-4BF4-9E3D-A23CCCCC9FE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526536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1FC4D3-CDC5-46F2-91B6-FE483614515A}" type="datetimeFigureOut">
              <a:rPr lang="en-IN" smtClean="0"/>
              <a:t>01-03-2024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7B13F-1CF0-4BF4-9E3D-A23CCCCC9FE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234150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1FC4D3-CDC5-46F2-91B6-FE483614515A}" type="datetimeFigureOut">
              <a:rPr lang="en-IN" smtClean="0"/>
              <a:t>01-03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7B13F-1CF0-4BF4-9E3D-A23CCCCC9FE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592844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1FC4D3-CDC5-46F2-91B6-FE483614515A}" type="datetimeFigureOut">
              <a:rPr lang="en-IN" smtClean="0"/>
              <a:t>01-03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7B13F-1CF0-4BF4-9E3D-A23CCCCC9FE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937743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1FC4D3-CDC5-46F2-91B6-FE483614515A}" type="datetimeFigureOut">
              <a:rPr lang="en-IN" smtClean="0"/>
              <a:t>01-03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C7B13F-1CF0-4BF4-9E3D-A23CCCCC9FE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214599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477"/>
          <a:stretch/>
        </p:blipFill>
        <p:spPr>
          <a:xfrm flipH="1">
            <a:off x="2663766" y="844628"/>
            <a:ext cx="4071490" cy="4461309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687" t="37344" r="19089" b="52273"/>
          <a:stretch/>
        </p:blipFill>
        <p:spPr>
          <a:xfrm flipH="1">
            <a:off x="3197770" y="5393931"/>
            <a:ext cx="3582304" cy="462013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197770" y="1066424"/>
            <a:ext cx="32340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b="1" dirty="0" smtClean="0"/>
              <a:t>      NT      SRT     DMF     S+DMF  L+N</a:t>
            </a:r>
            <a:endParaRPr lang="en-IN" sz="1600" b="1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rcRect r="3002" b="10046"/>
          <a:stretch/>
        </p:blipFill>
        <p:spPr>
          <a:xfrm flipH="1">
            <a:off x="7509228" y="986589"/>
            <a:ext cx="4161322" cy="4369869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8224617" y="1054965"/>
            <a:ext cx="32340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b="1" dirty="0" smtClean="0"/>
              <a:t>      NT      SRT     DMF     S+DMF  L+N</a:t>
            </a:r>
            <a:endParaRPr lang="en-IN" sz="16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1884211" y="1532888"/>
            <a:ext cx="6404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/>
              <a:t>kDa</a:t>
            </a:r>
            <a:endParaRPr lang="en-IN" dirty="0"/>
          </a:p>
        </p:txBody>
      </p:sp>
      <p:sp>
        <p:nvSpPr>
          <p:cNvPr id="11" name="TextBox 10"/>
          <p:cNvSpPr txBox="1"/>
          <p:nvPr/>
        </p:nvSpPr>
        <p:spPr>
          <a:xfrm>
            <a:off x="2054862" y="2246498"/>
            <a:ext cx="5919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54</a:t>
            </a:r>
            <a:endParaRPr lang="en-IN" sz="1200" dirty="0"/>
          </a:p>
        </p:txBody>
      </p:sp>
      <p:sp>
        <p:nvSpPr>
          <p:cNvPr id="12" name="TextBox 11"/>
          <p:cNvSpPr txBox="1"/>
          <p:nvPr/>
        </p:nvSpPr>
        <p:spPr>
          <a:xfrm>
            <a:off x="2002433" y="2573288"/>
            <a:ext cx="5919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43</a:t>
            </a:r>
            <a:endParaRPr lang="en-IN" sz="1200" dirty="0"/>
          </a:p>
        </p:txBody>
      </p:sp>
      <p:sp>
        <p:nvSpPr>
          <p:cNvPr id="13" name="TextBox 12"/>
          <p:cNvSpPr txBox="1"/>
          <p:nvPr/>
        </p:nvSpPr>
        <p:spPr>
          <a:xfrm>
            <a:off x="2038619" y="3013072"/>
            <a:ext cx="5919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33</a:t>
            </a:r>
            <a:endParaRPr lang="en-IN" sz="1200" dirty="0"/>
          </a:p>
        </p:txBody>
      </p:sp>
      <p:sp>
        <p:nvSpPr>
          <p:cNvPr id="14" name="TextBox 13"/>
          <p:cNvSpPr txBox="1"/>
          <p:nvPr/>
        </p:nvSpPr>
        <p:spPr>
          <a:xfrm>
            <a:off x="2066417" y="4471209"/>
            <a:ext cx="5919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16</a:t>
            </a:r>
            <a:endParaRPr lang="en-IN" sz="1200" dirty="0"/>
          </a:p>
        </p:txBody>
      </p:sp>
      <p:cxnSp>
        <p:nvCxnSpPr>
          <p:cNvPr id="15" name="Straight Connector 14"/>
          <p:cNvCxnSpPr/>
          <p:nvPr/>
        </p:nvCxnSpPr>
        <p:spPr>
          <a:xfrm flipH="1">
            <a:off x="2429328" y="2391286"/>
            <a:ext cx="27913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 flipH="1">
            <a:off x="2411561" y="2733174"/>
            <a:ext cx="27913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 flipH="1">
            <a:off x="2411561" y="3192887"/>
            <a:ext cx="27913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6887" y="2329107"/>
            <a:ext cx="2156757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dirty="0" smtClean="0"/>
              <a:t>Anti GSDMD: 53kDa</a:t>
            </a:r>
          </a:p>
          <a:p>
            <a:endParaRPr lang="en-IN" sz="1600" dirty="0"/>
          </a:p>
          <a:p>
            <a:endParaRPr lang="en-IN" sz="1600" dirty="0"/>
          </a:p>
          <a:p>
            <a:r>
              <a:rPr lang="en-IN" sz="1600" dirty="0" smtClean="0"/>
              <a:t>N terminal : 31kDa</a:t>
            </a:r>
            <a:endParaRPr lang="en-IN" sz="1600" dirty="0"/>
          </a:p>
        </p:txBody>
      </p:sp>
      <p:cxnSp>
        <p:nvCxnSpPr>
          <p:cNvPr id="19" name="Straight Connector 18"/>
          <p:cNvCxnSpPr/>
          <p:nvPr/>
        </p:nvCxnSpPr>
        <p:spPr>
          <a:xfrm flipH="1">
            <a:off x="2463249" y="4609708"/>
            <a:ext cx="27913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1483549" y="5436645"/>
            <a:ext cx="13330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 smtClean="0"/>
              <a:t>B-actin</a:t>
            </a:r>
            <a:endParaRPr lang="en-IN" dirty="0"/>
          </a:p>
        </p:txBody>
      </p:sp>
      <p:sp>
        <p:nvSpPr>
          <p:cNvPr id="21" name="TextBox 20"/>
          <p:cNvSpPr txBox="1"/>
          <p:nvPr/>
        </p:nvSpPr>
        <p:spPr>
          <a:xfrm>
            <a:off x="2150056" y="76298"/>
            <a:ext cx="86983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b="1" dirty="0" smtClean="0"/>
              <a:t>Cleavage of GSDMD upon SRT treatment</a:t>
            </a:r>
            <a:endParaRPr lang="en-IN" b="1" dirty="0"/>
          </a:p>
        </p:txBody>
      </p:sp>
      <p:cxnSp>
        <p:nvCxnSpPr>
          <p:cNvPr id="24" name="Straight Connector 23"/>
          <p:cNvCxnSpPr/>
          <p:nvPr/>
        </p:nvCxnSpPr>
        <p:spPr>
          <a:xfrm flipH="1">
            <a:off x="2365395" y="4078717"/>
            <a:ext cx="27913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2006481" y="3944936"/>
            <a:ext cx="5919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29</a:t>
            </a:r>
            <a:endParaRPr lang="en-IN" sz="1200" dirty="0"/>
          </a:p>
        </p:txBody>
      </p:sp>
    </p:spTree>
    <p:extLst>
      <p:ext uri="{BB962C8B-B14F-4D97-AF65-F5344CB8AC3E}">
        <p14:creationId xmlns:p14="http://schemas.microsoft.com/office/powerpoint/2010/main" val="421823900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  <p:bldP spid="11" grpId="0"/>
      <p:bldP spid="12" grpId="0"/>
      <p:bldP spid="13" grpId="0"/>
      <p:bldP spid="14" grpId="0"/>
      <p:bldP spid="18" grpId="0"/>
      <p:bldP spid="26" grpId="0"/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5649668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3</TotalTime>
  <Words>33</Words>
  <Application>Microsoft Office PowerPoint</Application>
  <PresentationFormat>Widescreen</PresentationFormat>
  <Paragraphs>1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jali singh</dc:creator>
  <cp:lastModifiedBy>anjali singh</cp:lastModifiedBy>
  <cp:revision>4</cp:revision>
  <dcterms:created xsi:type="dcterms:W3CDTF">2023-07-31T17:43:47Z</dcterms:created>
  <dcterms:modified xsi:type="dcterms:W3CDTF">2024-03-01T12:47:42Z</dcterms:modified>
</cp:coreProperties>
</file>